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335713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194211D-FF60-4BCB-8869-3AE30413DBA0}" type="datetime">
              <a:rPr b="0" lang="ja-JP" sz="1200" spc="-1" strike="noStrike">
                <a:solidFill>
                  <a:srgbClr val="000000"/>
                </a:solidFill>
                <a:latin typeface="Arial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332080" y="685440"/>
            <a:ext cx="2193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 Unicode MS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91A0218-BA49-4CFE-92B6-203519B64460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sldImg"/>
          </p:nvPr>
        </p:nvSpPr>
        <p:spPr>
          <a:xfrm>
            <a:off x="2332080" y="685800"/>
            <a:ext cx="2193840" cy="3429000"/>
          </a:xfrm>
          <a:prstGeom prst="rect">
            <a:avLst/>
          </a:prstGeom>
          <a:ln w="0">
            <a:noFill/>
          </a:ln>
        </p:spPr>
      </p:sp>
      <p:sp>
        <p:nvSpPr>
          <p:cNvPr id="10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9FD463-2264-49E4-8141-0DACADE5A506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E26102-6740-4781-97CB-F1C467CF9E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57024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17520" y="5725800"/>
            <a:ext cx="57024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CA638C-D661-4049-A348-F6697624D3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1752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23964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017AE1-B38F-45D8-AFAE-60145E37B88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45680" y="23112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173840" y="23112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17520" y="57258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45680" y="57258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173840" y="57258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3186B1-3E38-4421-B451-F35ED20458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17520" y="2311200"/>
            <a:ext cx="57024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AADDD6-8212-407B-B9DB-D1C148E629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57024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61CF1A-3583-4A53-BA62-C2153D6277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16EF0F-B70C-4B36-B91E-C74EFAE84A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DAA55E-FD57-48F6-964D-925D4445EC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17520" y="396360"/>
            <a:ext cx="57024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3E9C98-9AD3-4992-8CB4-0FB008FB7E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1752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6EAD22-3BF6-4E6E-953E-7992F093FE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23964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F84052-82C5-4485-913D-0612D906F4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17520" y="5725800"/>
            <a:ext cx="57024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6A5ED3-AE16-4A86-9036-DB3A63B061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 Unicode MS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17520" y="2311200"/>
            <a:ext cx="57024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17160" y="9182160"/>
            <a:ext cx="1477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E1FF0D-A182-4C35-A094-1202621DB4C1}" type="datetime">
              <a: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65400" y="9182160"/>
            <a:ext cx="200664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41760" y="9182160"/>
            <a:ext cx="14781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F9ACA1-6AE7-4379-A722-C792D59867F8}" type="slidenum">
              <a: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グループ化 58"/>
          <p:cNvGrpSpPr/>
          <p:nvPr/>
        </p:nvGrpSpPr>
        <p:grpSpPr>
          <a:xfrm>
            <a:off x="2771640" y="3390840"/>
            <a:ext cx="3458880" cy="1978200"/>
            <a:chOff x="2771640" y="3390840"/>
            <a:chExt cx="3458880" cy="1978200"/>
          </a:xfrm>
        </p:grpSpPr>
        <p:grpSp>
          <p:nvGrpSpPr>
            <p:cNvPr id="49" name="グループ化 68"/>
            <p:cNvGrpSpPr/>
            <p:nvPr/>
          </p:nvGrpSpPr>
          <p:grpSpPr>
            <a:xfrm>
              <a:off x="5899320" y="3848760"/>
              <a:ext cx="331200" cy="855360"/>
              <a:chOff x="5899320" y="3848760"/>
              <a:chExt cx="331200" cy="855360"/>
            </a:xfrm>
          </p:grpSpPr>
          <p:sp>
            <p:nvSpPr>
              <p:cNvPr id="50" name="直線コネクタ 7"/>
              <p:cNvSpPr/>
              <p:nvPr/>
            </p:nvSpPr>
            <p:spPr>
              <a:xfrm>
                <a:off x="5899320" y="3848760"/>
                <a:ext cx="179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直線コネクタ 8"/>
              <p:cNvSpPr/>
              <p:nvPr/>
            </p:nvSpPr>
            <p:spPr>
              <a:xfrm>
                <a:off x="5899320" y="4704120"/>
                <a:ext cx="179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直線コネクタ 9"/>
              <p:cNvSpPr/>
              <p:nvPr/>
            </p:nvSpPr>
            <p:spPr>
              <a:xfrm>
                <a:off x="6078600" y="3848760"/>
                <a:ext cx="0" cy="855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テキスト ボックス 10"/>
              <p:cNvSpPr/>
              <p:nvPr/>
            </p:nvSpPr>
            <p:spPr>
              <a:xfrm rot="5400000">
                <a:off x="6004080" y="415404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4" name="テキスト ボックス 4"/>
            <p:cNvSpPr/>
            <p:nvPr/>
          </p:nvSpPr>
          <p:spPr>
            <a:xfrm>
              <a:off x="5777640" y="5107680"/>
              <a:ext cx="33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47800"/>
                  <a:tab algn="l" pos="1695600"/>
                  <a:tab algn="l" pos="2543040"/>
                  <a:tab algn="l" pos="3390840"/>
                  <a:tab algn="l" pos="4238640"/>
                  <a:tab algn="l" pos="5086440"/>
                  <a:tab algn="l" pos="5934240"/>
                  <a:tab algn="l" pos="6781680"/>
                  <a:tab algn="l" pos="7629480"/>
                  <a:tab algn="l" pos="8477280"/>
                  <a:tab algn="l" pos="9325080"/>
                  <a:tab algn="l" pos="1017288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W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テキスト ボックス 5"/>
            <p:cNvSpPr/>
            <p:nvPr/>
          </p:nvSpPr>
          <p:spPr>
            <a:xfrm rot="16200000">
              <a:off x="2277000" y="4257000"/>
              <a:ext cx="1204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47800"/>
                  <a:tab algn="l" pos="1695600"/>
                  <a:tab algn="l" pos="2543040"/>
                  <a:tab algn="l" pos="3390840"/>
                  <a:tab algn="l" pos="4238640"/>
                  <a:tab algn="l" pos="5086440"/>
                  <a:tab algn="l" pos="5934240"/>
                  <a:tab algn="l" pos="6781680"/>
                  <a:tab algn="l" pos="7629480"/>
                  <a:tab algn="l" pos="8477280"/>
                  <a:tab algn="l" pos="9325080"/>
                  <a:tab algn="l" pos="1017288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Tumor Volume (mm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 Unicode MS"/>
                  <a:ea typeface="Arial Unicode MS"/>
                </a:rPr>
                <a:t>3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6" name="グラフ 6" descr=""/>
            <p:cNvPicPr/>
            <p:nvPr/>
          </p:nvPicPr>
          <p:blipFill>
            <a:blip r:embed="rId1"/>
            <a:stretch/>
          </p:blipFill>
          <p:spPr>
            <a:xfrm>
              <a:off x="2962440" y="3390840"/>
              <a:ext cx="3109320" cy="19782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7" name="テキスト ボックス 142"/>
          <p:cNvSpPr/>
          <p:nvPr/>
        </p:nvSpPr>
        <p:spPr>
          <a:xfrm>
            <a:off x="1440" y="295200"/>
            <a:ext cx="25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テキスト ボックス 142"/>
          <p:cNvSpPr/>
          <p:nvPr/>
        </p:nvSpPr>
        <p:spPr>
          <a:xfrm>
            <a:off x="-360" y="2936880"/>
            <a:ext cx="26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テキスト ボックス 141"/>
          <p:cNvSpPr/>
          <p:nvPr/>
        </p:nvSpPr>
        <p:spPr>
          <a:xfrm>
            <a:off x="-25560" y="0"/>
            <a:ext cx="1767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upplementary Figure S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0" name="グループ化 57"/>
          <p:cNvGrpSpPr/>
          <p:nvPr/>
        </p:nvGrpSpPr>
        <p:grpSpPr>
          <a:xfrm>
            <a:off x="24480" y="3040200"/>
            <a:ext cx="2611440" cy="2199960"/>
            <a:chOff x="24480" y="3040200"/>
            <a:chExt cx="2611440" cy="2199960"/>
          </a:xfrm>
        </p:grpSpPr>
        <p:grpSp>
          <p:nvGrpSpPr>
            <p:cNvPr id="61" name="グループ化 30"/>
            <p:cNvGrpSpPr/>
            <p:nvPr/>
          </p:nvGrpSpPr>
          <p:grpSpPr>
            <a:xfrm>
              <a:off x="603000" y="3040200"/>
              <a:ext cx="2032920" cy="2199960"/>
              <a:chOff x="603000" y="3040200"/>
              <a:chExt cx="2032920" cy="2199960"/>
            </a:xfrm>
          </p:grpSpPr>
          <p:sp>
            <p:nvSpPr>
              <p:cNvPr id="62" name="テキスト ボックス 12"/>
              <p:cNvSpPr/>
              <p:nvPr/>
            </p:nvSpPr>
            <p:spPr>
              <a:xfrm>
                <a:off x="2049120" y="4115520"/>
                <a:ext cx="586800" cy="207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960" rIns="84960" tIns="42480" bIns="4248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AFAP1L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テキスト ボックス 13"/>
              <p:cNvSpPr/>
              <p:nvPr/>
            </p:nvSpPr>
            <p:spPr>
              <a:xfrm rot="16200000">
                <a:off x="786240" y="3611160"/>
                <a:ext cx="737640" cy="222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960" rIns="84960" tIns="42480" bIns="4248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AFAP1L1-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テキスト ボックス 14"/>
              <p:cNvSpPr/>
              <p:nvPr/>
            </p:nvSpPr>
            <p:spPr>
              <a:xfrm rot="16200000">
                <a:off x="1647360" y="3777120"/>
                <a:ext cx="444960" cy="222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960" rIns="84960" tIns="42480" bIns="4248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Lac Z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テキスト ボックス 15"/>
              <p:cNvSpPr/>
              <p:nvPr/>
            </p:nvSpPr>
            <p:spPr>
              <a:xfrm rot="16200000">
                <a:off x="488160" y="3704400"/>
                <a:ext cx="618840" cy="222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960" rIns="84960" tIns="42480" bIns="4248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Parental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テキスト ボックス 16"/>
              <p:cNvSpPr/>
              <p:nvPr/>
            </p:nvSpPr>
            <p:spPr>
              <a:xfrm>
                <a:off x="2041920" y="4414680"/>
                <a:ext cx="524160" cy="207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960" rIns="84960" tIns="42480" bIns="4248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GAPDH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テキスト ボックス 17"/>
              <p:cNvSpPr/>
              <p:nvPr/>
            </p:nvSpPr>
            <p:spPr>
              <a:xfrm rot="16200000">
                <a:off x="1143360" y="3622320"/>
                <a:ext cx="737640" cy="222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960" rIns="84960" tIns="42480" bIns="4248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AFAP1L1-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テキスト ボックス 20"/>
              <p:cNvSpPr/>
              <p:nvPr/>
            </p:nvSpPr>
            <p:spPr>
              <a:xfrm>
                <a:off x="2049120" y="4696920"/>
                <a:ext cx="586800" cy="207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960" rIns="84960" tIns="42480" bIns="4248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AFAP1L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テキスト ボックス 21"/>
              <p:cNvSpPr/>
              <p:nvPr/>
            </p:nvSpPr>
            <p:spPr>
              <a:xfrm>
                <a:off x="2028240" y="4992480"/>
                <a:ext cx="507600" cy="207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960" rIns="84960" tIns="42480" bIns="4248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l-GR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β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-Acti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テキスト ボックス 22"/>
              <p:cNvSpPr/>
              <p:nvPr/>
            </p:nvSpPr>
            <p:spPr>
              <a:xfrm>
                <a:off x="768600" y="3040200"/>
                <a:ext cx="1170000" cy="237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84960" rIns="84960" tIns="42480" bIns="4248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48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直線コネクタ 24"/>
              <p:cNvSpPr/>
              <p:nvPr/>
            </p:nvSpPr>
            <p:spPr>
              <a:xfrm>
                <a:off x="651960" y="3309840"/>
                <a:ext cx="1403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2" name="Picture 30" descr="C:\Users\Ryo\Desktop\図36.png"/>
              <p:cNvPicPr/>
              <p:nvPr/>
            </p:nvPicPr>
            <p:blipFill>
              <a:blip r:embed="rId2"/>
              <a:stretch/>
            </p:blipFill>
            <p:spPr>
              <a:xfrm>
                <a:off x="603000" y="4087800"/>
                <a:ext cx="1481040" cy="115236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73" name="直線コネクタ 25"/>
            <p:cNvSpPr/>
            <p:nvPr/>
          </p:nvSpPr>
          <p:spPr>
            <a:xfrm>
              <a:off x="563400" y="4146480"/>
              <a:ext cx="0" cy="4680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テキスト ボックス 3"/>
            <p:cNvSpPr/>
            <p:nvPr/>
          </p:nvSpPr>
          <p:spPr>
            <a:xfrm>
              <a:off x="24480" y="426564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47800"/>
                  <a:tab algn="l" pos="1695600"/>
                  <a:tab algn="l" pos="2543040"/>
                  <a:tab algn="l" pos="3390840"/>
                  <a:tab algn="l" pos="4238640"/>
                  <a:tab algn="l" pos="5086440"/>
                  <a:tab algn="l" pos="5934240"/>
                  <a:tab algn="l" pos="6781680"/>
                  <a:tab algn="l" pos="7629480"/>
                  <a:tab algn="l" pos="8477280"/>
                  <a:tab algn="l" pos="9325080"/>
                  <a:tab algn="l" pos="1017288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RT-PC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直線コネクタ 30"/>
            <p:cNvSpPr/>
            <p:nvPr/>
          </p:nvSpPr>
          <p:spPr>
            <a:xfrm>
              <a:off x="563400" y="4726080"/>
              <a:ext cx="0" cy="4665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テキスト ボックス 3"/>
            <p:cNvSpPr/>
            <p:nvPr/>
          </p:nvSpPr>
          <p:spPr>
            <a:xfrm>
              <a:off x="250560" y="4843440"/>
              <a:ext cx="362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47800"/>
                  <a:tab algn="l" pos="1695600"/>
                  <a:tab algn="l" pos="2543040"/>
                  <a:tab algn="l" pos="3390840"/>
                  <a:tab algn="l" pos="4238640"/>
                  <a:tab algn="l" pos="5086440"/>
                  <a:tab algn="l" pos="5934240"/>
                  <a:tab algn="l" pos="6781680"/>
                  <a:tab algn="l" pos="7629480"/>
                  <a:tab algn="l" pos="8477280"/>
                  <a:tab algn="l" pos="9325080"/>
                  <a:tab algn="l" pos="1017288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WB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7" name="グループ化 55"/>
          <p:cNvGrpSpPr/>
          <p:nvPr/>
        </p:nvGrpSpPr>
        <p:grpSpPr>
          <a:xfrm>
            <a:off x="283320" y="477360"/>
            <a:ext cx="5138640" cy="2099160"/>
            <a:chOff x="283320" y="477360"/>
            <a:chExt cx="5138640" cy="2099160"/>
          </a:xfrm>
        </p:grpSpPr>
        <p:grpSp>
          <p:nvGrpSpPr>
            <p:cNvPr id="78" name="グループ化 26"/>
            <p:cNvGrpSpPr/>
            <p:nvPr/>
          </p:nvGrpSpPr>
          <p:grpSpPr>
            <a:xfrm>
              <a:off x="898560" y="477360"/>
              <a:ext cx="4523400" cy="2099160"/>
              <a:chOff x="898560" y="477360"/>
              <a:chExt cx="4523400" cy="2099160"/>
            </a:xfrm>
          </p:grpSpPr>
          <p:sp>
            <p:nvSpPr>
              <p:cNvPr id="79" name="テキスト ボックス 3"/>
              <p:cNvSpPr/>
              <p:nvPr/>
            </p:nvSpPr>
            <p:spPr>
              <a:xfrm>
                <a:off x="4825080" y="1213560"/>
                <a:ext cx="59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AFAP1L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テキスト ボックス 4"/>
              <p:cNvSpPr/>
              <p:nvPr/>
            </p:nvSpPr>
            <p:spPr>
              <a:xfrm>
                <a:off x="4817880" y="1571040"/>
                <a:ext cx="534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GAPDH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テキスト ボックス 9"/>
              <p:cNvSpPr/>
              <p:nvPr/>
            </p:nvSpPr>
            <p:spPr>
              <a:xfrm rot="17760000">
                <a:off x="857160" y="723600"/>
                <a:ext cx="639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HCT11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テキスト ボックス 10"/>
              <p:cNvSpPr/>
              <p:nvPr/>
            </p:nvSpPr>
            <p:spPr>
              <a:xfrm rot="17760000">
                <a:off x="1131840" y="757800"/>
                <a:ext cx="5832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48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テキスト ボックス 11"/>
              <p:cNvSpPr/>
              <p:nvPr/>
            </p:nvSpPr>
            <p:spPr>
              <a:xfrm rot="17760000">
                <a:off x="1450080" y="756360"/>
                <a:ext cx="5832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W6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テキスト ボックス 12"/>
              <p:cNvSpPr/>
              <p:nvPr/>
            </p:nvSpPr>
            <p:spPr>
              <a:xfrm rot="17760000">
                <a:off x="1785600" y="757080"/>
                <a:ext cx="545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DLD-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テキスト ボックス 13"/>
              <p:cNvSpPr/>
              <p:nvPr/>
            </p:nvSpPr>
            <p:spPr>
              <a:xfrm rot="17760000">
                <a:off x="2395080" y="800280"/>
                <a:ext cx="488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HT29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テキスト ボックス 14"/>
              <p:cNvSpPr/>
              <p:nvPr/>
            </p:nvSpPr>
            <p:spPr>
              <a:xfrm rot="17760000">
                <a:off x="2063880" y="754200"/>
                <a:ext cx="567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HCT1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テキスト ボックス 15"/>
              <p:cNvSpPr/>
              <p:nvPr/>
            </p:nvSpPr>
            <p:spPr>
              <a:xfrm rot="17760000">
                <a:off x="2664360" y="735120"/>
                <a:ext cx="581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Caco-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テキスト ボックス 16"/>
              <p:cNvSpPr/>
              <p:nvPr/>
            </p:nvSpPr>
            <p:spPr>
              <a:xfrm rot="17760000">
                <a:off x="3003120" y="820440"/>
                <a:ext cx="444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Colo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テキスト ボックス 17"/>
              <p:cNvSpPr/>
              <p:nvPr/>
            </p:nvSpPr>
            <p:spPr>
              <a:xfrm rot="17760000">
                <a:off x="3224520" y="704520"/>
                <a:ext cx="659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Colo20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テキスト ボックス 18"/>
              <p:cNvSpPr/>
              <p:nvPr/>
            </p:nvSpPr>
            <p:spPr>
              <a:xfrm rot="17760000">
                <a:off x="3585960" y="804600"/>
                <a:ext cx="474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LoVo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テキスト ボックス 19"/>
              <p:cNvSpPr/>
              <p:nvPr/>
            </p:nvSpPr>
            <p:spPr>
              <a:xfrm rot="17760000">
                <a:off x="3893760" y="816840"/>
                <a:ext cx="474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WiD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テキスト ボックス 20"/>
              <p:cNvSpPr/>
              <p:nvPr/>
            </p:nvSpPr>
            <p:spPr>
              <a:xfrm rot="17760000">
                <a:off x="4170960" y="784440"/>
                <a:ext cx="506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HCA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テキスト ボックス 21"/>
              <p:cNvSpPr/>
              <p:nvPr/>
            </p:nvSpPr>
            <p:spPr>
              <a:xfrm rot="17760000">
                <a:off x="4479840" y="819360"/>
                <a:ext cx="436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RKO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テキスト ボックス 3"/>
              <p:cNvSpPr/>
              <p:nvPr/>
            </p:nvSpPr>
            <p:spPr>
              <a:xfrm>
                <a:off x="4825080" y="1928520"/>
                <a:ext cx="596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AFAP1L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テキスト ボックス 22"/>
              <p:cNvSpPr/>
              <p:nvPr/>
            </p:nvSpPr>
            <p:spPr>
              <a:xfrm>
                <a:off x="4803840" y="2286360"/>
                <a:ext cx="5176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847800"/>
                    <a:tab algn="l" pos="1695600"/>
                    <a:tab algn="l" pos="2543040"/>
                    <a:tab algn="l" pos="3390840"/>
                    <a:tab algn="l" pos="4238640"/>
                    <a:tab algn="l" pos="5086440"/>
                    <a:tab algn="l" pos="5934240"/>
                    <a:tab algn="l" pos="6781680"/>
                    <a:tab algn="l" pos="7629480"/>
                    <a:tab algn="l" pos="8477280"/>
                    <a:tab algn="l" pos="9325080"/>
                    <a:tab algn="l" pos="10172880"/>
                  </a:tabLst>
                </a:pPr>
                <a:r>
                  <a:rPr b="0" lang="el-GR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β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-Acti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96" name="Picture 26" descr="C:\Users\Ryo\Desktop\図35.png"/>
              <p:cNvPicPr/>
              <p:nvPr/>
            </p:nvPicPr>
            <p:blipFill>
              <a:blip r:embed="rId3"/>
              <a:stretch/>
            </p:blipFill>
            <p:spPr>
              <a:xfrm>
                <a:off x="898560" y="1161720"/>
                <a:ext cx="3943080" cy="141480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97" name="直線コネクタ 50"/>
            <p:cNvSpPr/>
            <p:nvPr/>
          </p:nvSpPr>
          <p:spPr>
            <a:xfrm>
              <a:off x="822240" y="1219320"/>
              <a:ext cx="0" cy="5745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テキスト ボックス 3"/>
            <p:cNvSpPr/>
            <p:nvPr/>
          </p:nvSpPr>
          <p:spPr>
            <a:xfrm>
              <a:off x="283320" y="139068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47800"/>
                  <a:tab algn="l" pos="1695600"/>
                  <a:tab algn="l" pos="2543040"/>
                  <a:tab algn="l" pos="3390840"/>
                  <a:tab algn="l" pos="4238640"/>
                  <a:tab algn="l" pos="5086440"/>
                  <a:tab algn="l" pos="5934240"/>
                  <a:tab algn="l" pos="6781680"/>
                  <a:tab algn="l" pos="7629480"/>
                  <a:tab algn="l" pos="8477280"/>
                  <a:tab algn="l" pos="9325080"/>
                  <a:tab algn="l" pos="1017288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RT-PC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直線コネクタ 52"/>
            <p:cNvSpPr/>
            <p:nvPr/>
          </p:nvSpPr>
          <p:spPr>
            <a:xfrm>
              <a:off x="822240" y="1920960"/>
              <a:ext cx="0" cy="5745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テキスト ボックス 3"/>
            <p:cNvSpPr/>
            <p:nvPr/>
          </p:nvSpPr>
          <p:spPr>
            <a:xfrm>
              <a:off x="509040" y="2092320"/>
              <a:ext cx="362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47800"/>
                  <a:tab algn="l" pos="1695600"/>
                  <a:tab algn="l" pos="2543040"/>
                  <a:tab algn="l" pos="3390840"/>
                  <a:tab algn="l" pos="4238640"/>
                  <a:tab algn="l" pos="5086440"/>
                  <a:tab algn="l" pos="5934240"/>
                  <a:tab algn="l" pos="6781680"/>
                  <a:tab algn="l" pos="7629480"/>
                  <a:tab algn="l" pos="8477280"/>
                  <a:tab algn="l" pos="9325080"/>
                  <a:tab algn="l" pos="1017288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WB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1" name="テキスト ボックス 142"/>
          <p:cNvSpPr/>
          <p:nvPr/>
        </p:nvSpPr>
        <p:spPr>
          <a:xfrm>
            <a:off x="2670840" y="2936880"/>
            <a:ext cx="24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テキスト ボックス 5"/>
          <p:cNvSpPr/>
          <p:nvPr/>
        </p:nvSpPr>
        <p:spPr>
          <a:xfrm rot="16200000">
            <a:off x="-93600" y="6590520"/>
            <a:ext cx="979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Fold chang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(relative to day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テキスト ボックス 4"/>
          <p:cNvSpPr/>
          <p:nvPr/>
        </p:nvSpPr>
        <p:spPr>
          <a:xfrm>
            <a:off x="3241440" y="7761240"/>
            <a:ext cx="365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Da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テキスト ボックス 4"/>
          <p:cNvSpPr/>
          <p:nvPr/>
        </p:nvSpPr>
        <p:spPr>
          <a:xfrm>
            <a:off x="1587240" y="574524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Arial Unicode MS"/>
                <a:ea typeface="Arial Unicode MS"/>
              </a:rPr>
              <a:t>LoV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テキスト ボックス 4"/>
          <p:cNvSpPr/>
          <p:nvPr/>
        </p:nvSpPr>
        <p:spPr>
          <a:xfrm>
            <a:off x="4258080" y="3297240"/>
            <a:ext cx="58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Arial Unicode MS"/>
                <a:ea typeface="Arial Unicode MS"/>
              </a:rPr>
              <a:t>SW4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テキスト ボックス 142"/>
          <p:cNvSpPr/>
          <p:nvPr/>
        </p:nvSpPr>
        <p:spPr>
          <a:xfrm>
            <a:off x="-360" y="5600880"/>
            <a:ext cx="26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7" name="グラフ 61" descr=""/>
          <p:cNvPicPr/>
          <p:nvPr/>
        </p:nvPicPr>
        <p:blipFill>
          <a:blip r:embed="rId4"/>
          <a:stretch/>
        </p:blipFill>
        <p:spPr>
          <a:xfrm>
            <a:off x="426960" y="5956200"/>
            <a:ext cx="3468600" cy="2028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10T07:50:08Z</dcterms:created>
  <dc:creator>Ryo　Takahashi</dc:creator>
  <dc:description/>
  <dc:language>en-US</dc:language>
  <cp:lastModifiedBy>戸口田 淳也</cp:lastModifiedBy>
  <dcterms:modified xsi:type="dcterms:W3CDTF">2014-02-18T03:12:35Z</dcterms:modified>
  <cp:revision>53</cp:revision>
  <dc:subject/>
  <dc:title>スライド 1</dc:title>
</cp:coreProperties>
</file>